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-72" y="28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109195-92C3-4589-90F3-F32DB81470F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176C42-8C97-4A8E-A7DC-3E0BB1FAF0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36773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176C42-8C97-4A8E-A7DC-3E0BB1FAF074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650937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833275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16234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957991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109559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741227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59833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048084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31156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131412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265278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209387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54659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645197" y="218087"/>
            <a:ext cx="17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upplementary Figure S2</a:t>
            </a:r>
            <a:endParaRPr lang="en-GB" sz="1200" dirty="0"/>
          </a:p>
        </p:txBody>
      </p:sp>
      <p:grpSp>
        <p:nvGrpSpPr>
          <p:cNvPr id="3" name="Group 2"/>
          <p:cNvGrpSpPr/>
          <p:nvPr/>
        </p:nvGrpSpPr>
        <p:grpSpPr>
          <a:xfrm>
            <a:off x="1040609" y="623366"/>
            <a:ext cx="4957762" cy="7320158"/>
            <a:chOff x="1040609" y="576068"/>
            <a:chExt cx="4957762" cy="7320158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0609" y="773909"/>
              <a:ext cx="2176462" cy="2176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1909" y="773909"/>
              <a:ext cx="2176462" cy="2176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0609" y="3236121"/>
              <a:ext cx="2176462" cy="2176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1909" y="3236121"/>
              <a:ext cx="2176462" cy="2176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0609" y="5719764"/>
              <a:ext cx="2176462" cy="2176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1909" y="5719764"/>
              <a:ext cx="2176462" cy="2176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1202625" y="589956"/>
              <a:ext cx="2584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a</a:t>
              </a:r>
              <a:endParaRPr lang="en-GB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941868" y="576068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b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93007" y="3026371"/>
              <a:ext cx="2503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941868" y="3046197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d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99272" y="5533764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e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65618" y="5545639"/>
              <a:ext cx="231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f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1062743" y="8133262"/>
            <a:ext cx="50777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/>
              <a:t>Supplementary Figure S2: Reads distribution on reference genes D0 (a), Pr-Fl-PLLA (b), Pr-Fs-PLLA (c), Am-Fl-PLLA (d), Am-Fs-PLLA (e), and TCP (f).</a:t>
            </a:r>
            <a:endParaRPr lang="en-GB" sz="1200" dirty="0"/>
          </a:p>
        </p:txBody>
      </p:sp>
    </p:spTree>
    <p:extLst>
      <p:ext uri="{BB962C8B-B14F-4D97-AF65-F5344CB8AC3E}">
        <p14:creationId xmlns="" xmlns:p14="http://schemas.microsoft.com/office/powerpoint/2010/main" val="854923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44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Dept of Zoology, University of Oxfo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i Wang</dc:creator>
  <cp:lastModifiedBy>Naresh Kasoju</cp:lastModifiedBy>
  <cp:revision>5</cp:revision>
  <dcterms:created xsi:type="dcterms:W3CDTF">2017-07-06T20:29:44Z</dcterms:created>
  <dcterms:modified xsi:type="dcterms:W3CDTF">2018-07-16T06:09:11Z</dcterms:modified>
</cp:coreProperties>
</file>